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B1C48-D6D9-4E21-9DBC-1C6DC0CFD6B0}" type="datetimeFigureOut">
              <a:rPr lang="en-US" smtClean="0"/>
              <a:t>1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1AC6-7B76-481F-BBFB-FB0BC60AA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06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B1C48-D6D9-4E21-9DBC-1C6DC0CFD6B0}" type="datetimeFigureOut">
              <a:rPr lang="en-US" smtClean="0"/>
              <a:t>1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1AC6-7B76-481F-BBFB-FB0BC60AA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077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B1C48-D6D9-4E21-9DBC-1C6DC0CFD6B0}" type="datetimeFigureOut">
              <a:rPr lang="en-US" smtClean="0"/>
              <a:t>1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1AC6-7B76-481F-BBFB-FB0BC60AA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522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B1C48-D6D9-4E21-9DBC-1C6DC0CFD6B0}" type="datetimeFigureOut">
              <a:rPr lang="en-US" smtClean="0"/>
              <a:t>1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1AC6-7B76-481F-BBFB-FB0BC60AA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051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B1C48-D6D9-4E21-9DBC-1C6DC0CFD6B0}" type="datetimeFigureOut">
              <a:rPr lang="en-US" smtClean="0"/>
              <a:t>1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1AC6-7B76-481F-BBFB-FB0BC60AA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16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B1C48-D6D9-4E21-9DBC-1C6DC0CFD6B0}" type="datetimeFigureOut">
              <a:rPr lang="en-US" smtClean="0"/>
              <a:t>1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1AC6-7B76-481F-BBFB-FB0BC60AA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416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B1C48-D6D9-4E21-9DBC-1C6DC0CFD6B0}" type="datetimeFigureOut">
              <a:rPr lang="en-US" smtClean="0"/>
              <a:t>1/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1AC6-7B76-481F-BBFB-FB0BC60AA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652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B1C48-D6D9-4E21-9DBC-1C6DC0CFD6B0}" type="datetimeFigureOut">
              <a:rPr lang="en-US" smtClean="0"/>
              <a:t>1/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1AC6-7B76-481F-BBFB-FB0BC60AA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855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B1C48-D6D9-4E21-9DBC-1C6DC0CFD6B0}" type="datetimeFigureOut">
              <a:rPr lang="en-US" smtClean="0"/>
              <a:t>1/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1AC6-7B76-481F-BBFB-FB0BC60AA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378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B1C48-D6D9-4E21-9DBC-1C6DC0CFD6B0}" type="datetimeFigureOut">
              <a:rPr lang="en-US" smtClean="0"/>
              <a:t>1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1AC6-7B76-481F-BBFB-FB0BC60AA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853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B1C48-D6D9-4E21-9DBC-1C6DC0CFD6B0}" type="datetimeFigureOut">
              <a:rPr lang="en-US" smtClean="0"/>
              <a:t>1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1AC6-7B76-481F-BBFB-FB0BC60AA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809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FB1C48-D6D9-4E21-9DBC-1C6DC0CFD6B0}" type="datetimeFigureOut">
              <a:rPr lang="en-US" smtClean="0"/>
              <a:t>1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2A1AC6-7B76-481F-BBFB-FB0BC60AA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1466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Rounded Rectangle 24"/>
          <p:cNvSpPr/>
          <p:nvPr/>
        </p:nvSpPr>
        <p:spPr>
          <a:xfrm>
            <a:off x="6690599" y="3029129"/>
            <a:ext cx="1904523" cy="526022"/>
          </a:xfrm>
          <a:prstGeom prst="roundRect">
            <a:avLst>
              <a:gd name="adj" fmla="val 10000"/>
            </a:avLst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tint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tint val="50000"/>
              <a:hueOff val="0"/>
              <a:satOff val="0"/>
              <a:lumOff val="0"/>
              <a:alphaOff val="0"/>
            </a:schemeClr>
          </a:effectRef>
          <a:fontRef idx="minor">
            <a:schemeClr val="lt1">
              <a:hueOff val="0"/>
              <a:satOff val="0"/>
              <a:lumOff val="0"/>
              <a:alphaOff val="0"/>
            </a:schemeClr>
          </a:fontRef>
        </p:style>
        <p:txBody>
          <a:bodyPr/>
          <a:lstStyle/>
          <a:p>
            <a:endParaRPr lang="en-US"/>
          </a:p>
        </p:txBody>
      </p:sp>
      <p:sp>
        <p:nvSpPr>
          <p:cNvPr id="28" name="Bent-Up Arrow 27"/>
          <p:cNvSpPr/>
          <p:nvPr/>
        </p:nvSpPr>
        <p:spPr>
          <a:xfrm rot="5400000">
            <a:off x="6182197" y="2894814"/>
            <a:ext cx="636850" cy="379954"/>
          </a:xfrm>
          <a:prstGeom prst="bentUpArrow">
            <a:avLst>
              <a:gd name="adj1" fmla="val 32981"/>
              <a:gd name="adj2" fmla="val 25000"/>
              <a:gd name="adj3" fmla="val 38968"/>
            </a:avLst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" name="Group 1"/>
          <p:cNvGrpSpPr/>
          <p:nvPr/>
        </p:nvGrpSpPr>
        <p:grpSpPr>
          <a:xfrm>
            <a:off x="1493004" y="1627903"/>
            <a:ext cx="2303590" cy="1389408"/>
            <a:chOff x="314081" y="2595694"/>
            <a:chExt cx="1904523" cy="1109834"/>
          </a:xfrm>
        </p:grpSpPr>
        <p:sp>
          <p:nvSpPr>
            <p:cNvPr id="3" name="Rounded Rectangle 2"/>
            <p:cNvSpPr/>
            <p:nvPr/>
          </p:nvSpPr>
          <p:spPr>
            <a:xfrm>
              <a:off x="314081" y="2595694"/>
              <a:ext cx="1904523" cy="1109834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4" name="Rounded Rectangle 4"/>
            <p:cNvSpPr txBox="1"/>
            <p:nvPr/>
          </p:nvSpPr>
          <p:spPr>
            <a:xfrm>
              <a:off x="348604" y="2638650"/>
              <a:ext cx="1835477" cy="1000673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spcFirstLastPara="0" vert="horz" wrap="square" lIns="53340" tIns="53340" rIns="53340" bIns="53340" numCol="1" spcCol="1270" anchor="ctr" anchorCtr="0">
              <a:noAutofit/>
            </a:bodyPr>
            <a:lstStyle/>
            <a:p>
              <a:pPr marL="112713" lvl="0" indent="-112713" defTabSz="622300"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kern="1200" dirty="0"/>
                <a:t>Communicate with dialysis administration and treating providers</a:t>
              </a:r>
            </a:p>
            <a:p>
              <a:pPr marL="112713" lvl="0" indent="-112713" defTabSz="622300"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kern="1200" dirty="0"/>
                <a:t>Identify new patients with diagnosis of KDRD and ≤18 HD </a:t>
              </a:r>
              <a:r>
                <a:rPr lang="en-US" sz="1400" dirty="0"/>
                <a:t>sessions</a:t>
              </a:r>
              <a:endParaRPr lang="en-US" sz="1800" kern="1200" dirty="0"/>
            </a:p>
          </p:txBody>
        </p:sp>
      </p:grpSp>
      <p:sp>
        <p:nvSpPr>
          <p:cNvPr id="5" name="Rounded Rectangle 4"/>
          <p:cNvSpPr/>
          <p:nvPr/>
        </p:nvSpPr>
        <p:spPr>
          <a:xfrm>
            <a:off x="1394102" y="931071"/>
            <a:ext cx="1904523" cy="711660"/>
          </a:xfrm>
          <a:prstGeom prst="roundRect">
            <a:avLst>
              <a:gd name="adj" fmla="val 10000"/>
            </a:avLst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tint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tint val="50000"/>
              <a:hueOff val="0"/>
              <a:satOff val="0"/>
              <a:lumOff val="0"/>
              <a:alphaOff val="0"/>
            </a:schemeClr>
          </a:effectRef>
          <a:fontRef idx="minor">
            <a:schemeClr val="lt1">
              <a:hueOff val="0"/>
              <a:satOff val="0"/>
              <a:lumOff val="0"/>
              <a:alphaOff val="0"/>
            </a:schemeClr>
          </a:fontRef>
        </p:style>
        <p:txBody>
          <a:bodyPr/>
          <a:lstStyle/>
          <a:p>
            <a:endParaRPr lang="en-US"/>
          </a:p>
        </p:txBody>
      </p:sp>
      <p:pic>
        <p:nvPicPr>
          <p:cNvPr id="6" name="Picture 2" descr="Checklist icon symbol design Royalty Free Vector Image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414" t="15022" r="14426" b="19951"/>
          <a:stretch/>
        </p:blipFill>
        <p:spPr bwMode="auto">
          <a:xfrm>
            <a:off x="2917221" y="1301873"/>
            <a:ext cx="321075" cy="3260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4" descr="Group vector icons Group vector icons. Simple illustration set of 9 Group elements, editable icons, can be used in symbol, UI and web design Adult stock vector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1249" t="43470" r="9035" b="44016"/>
          <a:stretch/>
        </p:blipFill>
        <p:spPr bwMode="auto">
          <a:xfrm>
            <a:off x="2705744" y="977784"/>
            <a:ext cx="529659" cy="3242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485996" y="931071"/>
            <a:ext cx="115652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Identify Study Candidates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3891714" y="1640647"/>
            <a:ext cx="2323811" cy="1915362"/>
            <a:chOff x="308271" y="2604127"/>
            <a:chExt cx="1904523" cy="1148108"/>
          </a:xfrm>
        </p:grpSpPr>
        <p:sp>
          <p:nvSpPr>
            <p:cNvPr id="10" name="Rounded Rectangle 9"/>
            <p:cNvSpPr/>
            <p:nvPr/>
          </p:nvSpPr>
          <p:spPr>
            <a:xfrm>
              <a:off x="308271" y="2604127"/>
              <a:ext cx="1904523" cy="1148108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1" name="Rounded Rectangle 4"/>
            <p:cNvSpPr txBox="1"/>
            <p:nvPr/>
          </p:nvSpPr>
          <p:spPr>
            <a:xfrm>
              <a:off x="321725" y="2675009"/>
              <a:ext cx="1824517" cy="102239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spcFirstLastPara="0" vert="horz" wrap="square" lIns="53340" tIns="53340" rIns="53340" bIns="53340" numCol="1" spcCol="1270" anchor="ctr" anchorCtr="0">
              <a:noAutofit/>
            </a:bodyPr>
            <a:lstStyle/>
            <a:p>
              <a:pPr marL="112713" lvl="0" indent="-112713" defTabSz="622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kern="1200" dirty="0"/>
                <a:t>Prescreening clinical criteria (EMR review) </a:t>
              </a:r>
              <a:endParaRPr lang="en-US" sz="1400" dirty="0"/>
            </a:p>
            <a:p>
              <a:pPr marL="112713" lvl="0" indent="-112713" defTabSz="622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kern="1200" dirty="0"/>
                <a:t>Informed consent</a:t>
              </a:r>
              <a:endParaRPr lang="en-US" sz="1400" dirty="0"/>
            </a:p>
            <a:p>
              <a:pPr marL="112713" lvl="0" indent="-112713" defTabSz="622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kern="1200" dirty="0"/>
                <a:t>Screening, baseline residual kidney function criteria </a:t>
              </a:r>
            </a:p>
            <a:p>
              <a:pPr marL="112713" lvl="0" indent="-112713" defTabSz="622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kern="1200" dirty="0"/>
                <a:t>Serum </a:t>
              </a:r>
              <a:r>
                <a:rPr lang="en-US" sz="1400" dirty="0"/>
                <a:t>pregnancy test (when applicable)</a:t>
              </a:r>
              <a:endParaRPr lang="en-US" sz="1800" kern="1200" dirty="0"/>
            </a:p>
          </p:txBody>
        </p:sp>
      </p:grpSp>
      <p:sp>
        <p:nvSpPr>
          <p:cNvPr id="12" name="Rounded Rectangle 11"/>
          <p:cNvSpPr/>
          <p:nvPr/>
        </p:nvSpPr>
        <p:spPr>
          <a:xfrm>
            <a:off x="3880530" y="931071"/>
            <a:ext cx="1838053" cy="713232"/>
          </a:xfrm>
          <a:prstGeom prst="roundRect">
            <a:avLst>
              <a:gd name="adj" fmla="val 10000"/>
            </a:avLst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tint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tint val="50000"/>
              <a:hueOff val="0"/>
              <a:satOff val="0"/>
              <a:lumOff val="0"/>
              <a:alphaOff val="0"/>
            </a:schemeClr>
          </a:effectRef>
          <a:fontRef idx="minor">
            <a:schemeClr val="lt1">
              <a:hueOff val="0"/>
              <a:satOff val="0"/>
              <a:lumOff val="0"/>
              <a:alphaOff val="0"/>
            </a:schemeClr>
          </a:fontRef>
        </p:style>
        <p:txBody>
          <a:bodyPr/>
          <a:lstStyle/>
          <a:p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3903584" y="715628"/>
            <a:ext cx="163243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400" b="1" dirty="0"/>
          </a:p>
          <a:p>
            <a:pPr algn="ctr"/>
            <a:r>
              <a:rPr lang="en-US" sz="1400" b="1" dirty="0"/>
              <a:t>Prescreening, Informed Consent, &amp; Screening</a:t>
            </a:r>
          </a:p>
        </p:txBody>
      </p:sp>
      <p:pic>
        <p:nvPicPr>
          <p:cNvPr id="14" name="Picture 6" descr="2 ways to remove the People icon from the taskbar in Windows 10 - Digital  Citizen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584" t="6762" r="30171" b="-122"/>
          <a:stretch/>
        </p:blipFill>
        <p:spPr bwMode="auto">
          <a:xfrm>
            <a:off x="5230430" y="1391110"/>
            <a:ext cx="402451" cy="3500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6" name="Group 15"/>
          <p:cNvGrpSpPr/>
          <p:nvPr/>
        </p:nvGrpSpPr>
        <p:grpSpPr>
          <a:xfrm>
            <a:off x="6300488" y="1628451"/>
            <a:ext cx="2340517" cy="1388860"/>
            <a:chOff x="314081" y="2604127"/>
            <a:chExt cx="1904523" cy="1093072"/>
          </a:xfrm>
        </p:grpSpPr>
        <p:sp>
          <p:nvSpPr>
            <p:cNvPr id="17" name="Rounded Rectangle 16"/>
            <p:cNvSpPr/>
            <p:nvPr/>
          </p:nvSpPr>
          <p:spPr>
            <a:xfrm>
              <a:off x="314081" y="2604127"/>
              <a:ext cx="1904523" cy="1093072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8" name="Rounded Rectangle 4"/>
            <p:cNvSpPr txBox="1"/>
            <p:nvPr/>
          </p:nvSpPr>
          <p:spPr>
            <a:xfrm>
              <a:off x="348603" y="2707947"/>
              <a:ext cx="1835477" cy="911805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spcFirstLastPara="0" vert="horz" wrap="square" lIns="53340" tIns="53340" rIns="53340" bIns="53340" numCol="1" spcCol="1270" anchor="ctr" anchorCtr="0">
              <a:noAutofit/>
            </a:bodyPr>
            <a:lstStyle/>
            <a:p>
              <a:pPr marL="112713" lvl="0" indent="-112713" defTabSz="622300">
                <a:lnSpc>
                  <a:spcPts val="1500"/>
                </a:lnSpc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kern="1200" dirty="0"/>
                <a:t>Baseline clinical data</a:t>
              </a:r>
            </a:p>
            <a:p>
              <a:pPr marL="112713" lvl="0" indent="-112713" defTabSz="622300">
                <a:lnSpc>
                  <a:spcPts val="1500"/>
                </a:lnSpc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dirty="0"/>
                <a:t>Contact caregiver</a:t>
              </a:r>
            </a:p>
            <a:p>
              <a:pPr marL="112713" lvl="0" indent="-112713" defTabSz="622300">
                <a:lnSpc>
                  <a:spcPts val="1500"/>
                </a:lnSpc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dirty="0"/>
                <a:t>Randomization</a:t>
              </a:r>
              <a:endParaRPr lang="en-US" sz="1400" kern="1200" dirty="0"/>
            </a:p>
            <a:p>
              <a:pPr marL="112713" lvl="0" indent="-112713" defTabSz="622300">
                <a:lnSpc>
                  <a:spcPts val="1500"/>
                </a:lnSpc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kern="1200" dirty="0"/>
                <a:t>Communicate with patient, dialysis personnel and treating providers</a:t>
              </a:r>
              <a:endParaRPr lang="en-US" sz="1800" kern="1200" dirty="0"/>
            </a:p>
          </p:txBody>
        </p:sp>
      </p:grpSp>
      <p:sp>
        <p:nvSpPr>
          <p:cNvPr id="19" name="Rounded Rectangle 18"/>
          <p:cNvSpPr/>
          <p:nvPr/>
        </p:nvSpPr>
        <p:spPr>
          <a:xfrm>
            <a:off x="6300488" y="931071"/>
            <a:ext cx="1904523" cy="711660"/>
          </a:xfrm>
          <a:prstGeom prst="roundRect">
            <a:avLst>
              <a:gd name="adj" fmla="val 10000"/>
            </a:avLst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tint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tint val="50000"/>
              <a:hueOff val="0"/>
              <a:satOff val="0"/>
              <a:lumOff val="0"/>
              <a:alphaOff val="0"/>
            </a:schemeClr>
          </a:effectRef>
          <a:fontRef idx="minor">
            <a:schemeClr val="lt1">
              <a:hueOff val="0"/>
              <a:satOff val="0"/>
              <a:lumOff val="0"/>
              <a:alphaOff val="0"/>
            </a:schemeClr>
          </a:fontRef>
        </p:style>
        <p:txBody>
          <a:bodyPr/>
          <a:lstStyle/>
          <a:p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6203181" y="1202808"/>
            <a:ext cx="1369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Enrollment </a:t>
            </a:r>
          </a:p>
        </p:txBody>
      </p:sp>
      <p:pic>
        <p:nvPicPr>
          <p:cNvPr id="21" name="Picture 20" descr="Group vector icons Group vector icons. Simple illustration set of 9 Group elements, editable icons, can be used in symbol, UI and web design Adult stock vector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844" t="39101" r="40204" b="38586"/>
          <a:stretch/>
        </p:blipFill>
        <p:spPr bwMode="auto">
          <a:xfrm>
            <a:off x="7500921" y="1014383"/>
            <a:ext cx="584999" cy="5619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2" name="Group 21"/>
          <p:cNvGrpSpPr/>
          <p:nvPr/>
        </p:nvGrpSpPr>
        <p:grpSpPr>
          <a:xfrm>
            <a:off x="6310645" y="3534252"/>
            <a:ext cx="2291507" cy="807352"/>
            <a:chOff x="314081" y="2604127"/>
            <a:chExt cx="1904523" cy="1178690"/>
          </a:xfrm>
        </p:grpSpPr>
        <p:sp>
          <p:nvSpPr>
            <p:cNvPr id="23" name="Rounded Rectangle 22"/>
            <p:cNvSpPr/>
            <p:nvPr/>
          </p:nvSpPr>
          <p:spPr>
            <a:xfrm>
              <a:off x="314081" y="2604127"/>
              <a:ext cx="1904523" cy="1178690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24" name="Rounded Rectangle 4"/>
            <p:cNvSpPr txBox="1"/>
            <p:nvPr/>
          </p:nvSpPr>
          <p:spPr>
            <a:xfrm>
              <a:off x="348603" y="2846832"/>
              <a:ext cx="1835477" cy="713095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spcFirstLastPara="0" vert="horz" wrap="square" lIns="53340" tIns="53340" rIns="53340" bIns="53340" numCol="1" spcCol="1270" anchor="ctr" anchorCtr="0">
              <a:noAutofit/>
            </a:bodyPr>
            <a:lstStyle/>
            <a:p>
              <a:pPr marL="112713" lvl="0" indent="-112713" defTabSz="622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kern="1200" dirty="0"/>
                <a:t>Caregiver eligibility criteria</a:t>
              </a:r>
            </a:p>
            <a:p>
              <a:pPr marL="112713" lvl="0" indent="-112713" defTabSz="622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dirty="0"/>
                <a:t>Informed Consent</a:t>
              </a:r>
            </a:p>
            <a:p>
              <a:pPr marL="112713" lvl="0" indent="-112713" defTabSz="622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Font typeface="Arial" panose="020B0604020202020204" pitchFamily="34" charset="0"/>
                <a:buChar char="•"/>
              </a:pPr>
              <a:r>
                <a:rPr lang="en-US" sz="1400" dirty="0"/>
                <a:t>Enrollment</a:t>
              </a:r>
              <a:endParaRPr lang="en-US" sz="1800" kern="1200" dirty="0"/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6836078" y="3017154"/>
            <a:ext cx="13691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aregiver Screening </a:t>
            </a:r>
          </a:p>
        </p:txBody>
      </p:sp>
      <p:pic>
        <p:nvPicPr>
          <p:cNvPr id="3074" name="Picture 2" descr="Icon-people - People Icon Black Png PNG Image | Transparent PNG Free  Download on Seek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10984" y="3098522"/>
            <a:ext cx="494074" cy="366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Right Arrow 26"/>
          <p:cNvSpPr/>
          <p:nvPr/>
        </p:nvSpPr>
        <p:spPr>
          <a:xfrm>
            <a:off x="3376617" y="1081269"/>
            <a:ext cx="472253" cy="406162"/>
          </a:xfrm>
          <a:prstGeom prst="right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ight Arrow 28"/>
          <p:cNvSpPr/>
          <p:nvPr/>
        </p:nvSpPr>
        <p:spPr>
          <a:xfrm>
            <a:off x="5796931" y="1079946"/>
            <a:ext cx="472253" cy="406162"/>
          </a:xfrm>
          <a:prstGeom prst="right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1223762" y="3691264"/>
            <a:ext cx="508298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MS Mincho"/>
              </a:rPr>
              <a:t>(A). </a:t>
            </a:r>
            <a:r>
              <a:rPr lang="en-US" sz="1400" dirty="0">
                <a:latin typeface="Calibri" panose="020F0502020204030204" pitchFamily="34" charset="0"/>
                <a:ea typeface="MS Mincho"/>
              </a:rPr>
              <a:t>Prescreening of clinical eligibility is based on electronic medical record (EMR) review. Those who pass prescreening will be approached for study participation and informed consent, followed</a:t>
            </a:r>
            <a:endParaRPr lang="en-US" sz="1400" dirty="0"/>
          </a:p>
        </p:txBody>
      </p:sp>
      <p:sp>
        <p:nvSpPr>
          <p:cNvPr id="32" name="TextBox 31"/>
          <p:cNvSpPr txBox="1"/>
          <p:nvPr/>
        </p:nvSpPr>
        <p:spPr>
          <a:xfrm>
            <a:off x="1362442" y="935028"/>
            <a:ext cx="36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rgbClr val="000090"/>
                </a:solidFill>
              </a:rPr>
              <a:t>A.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880174" y="959153"/>
            <a:ext cx="36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rgbClr val="000090"/>
                </a:solidFill>
              </a:rPr>
              <a:t>B.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6351190" y="939964"/>
            <a:ext cx="3533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rgbClr val="000090"/>
                </a:solidFill>
              </a:rPr>
              <a:t>C.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6694094" y="3029129"/>
            <a:ext cx="3533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rgbClr val="000090"/>
                </a:solidFill>
              </a:rPr>
              <a:t>D.</a:t>
            </a:r>
          </a:p>
        </p:txBody>
      </p:sp>
      <p:sp>
        <p:nvSpPr>
          <p:cNvPr id="36" name="Rectangle 35"/>
          <p:cNvSpPr/>
          <p:nvPr/>
        </p:nvSpPr>
        <p:spPr>
          <a:xfrm>
            <a:off x="1223762" y="3438026"/>
            <a:ext cx="279220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MS Mincho"/>
              </a:rPr>
              <a:t>Figure S2</a:t>
            </a:r>
            <a:r>
              <a:rPr lang="en-US" sz="1400" dirty="0">
                <a:latin typeface="Calibri" panose="020F0502020204030204" pitchFamily="34" charset="0"/>
                <a:ea typeface="MS Mincho"/>
              </a:rPr>
              <a:t>.</a:t>
            </a:r>
            <a:r>
              <a:rPr lang="en-US" sz="1400" b="1" dirty="0">
                <a:latin typeface="Calibri" panose="020F0502020204030204" pitchFamily="34" charset="0"/>
                <a:ea typeface="MS Mincho"/>
              </a:rPr>
              <a:t> Participant Recruitment </a:t>
            </a:r>
            <a:endParaRPr lang="en-US" sz="1400" dirty="0"/>
          </a:p>
        </p:txBody>
      </p:sp>
      <p:sp>
        <p:nvSpPr>
          <p:cNvPr id="37" name="Rectangle 36"/>
          <p:cNvSpPr/>
          <p:nvPr/>
        </p:nvSpPr>
        <p:spPr>
          <a:xfrm>
            <a:off x="1223762" y="4348750"/>
            <a:ext cx="7596965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MS Mincho"/>
              </a:rPr>
              <a:t>by screening with timed urine collection for baseline residual kidney function assessment. A serum pregnancy test will be obtained when applicable. </a:t>
            </a:r>
            <a:r>
              <a:rPr lang="en-US" sz="1400" b="1" dirty="0">
                <a:latin typeface="Calibri" panose="020F0502020204030204" pitchFamily="34" charset="0"/>
                <a:ea typeface="MS Mincho"/>
              </a:rPr>
              <a:t>(B)</a:t>
            </a:r>
            <a:r>
              <a:rPr lang="en-US" sz="1400" dirty="0">
                <a:latin typeface="Calibri" panose="020F0502020204030204" pitchFamily="34" charset="0"/>
                <a:ea typeface="MS Mincho"/>
              </a:rPr>
              <a:t>. If full eligibility criteria are met, eligible patients will complete baseline questionnaires, their caregivers will be approached for study participation, then then the patients will undergo randomization </a:t>
            </a:r>
            <a:r>
              <a:rPr lang="en-US" sz="1400" b="1" dirty="0">
                <a:latin typeface="Calibri" panose="020F0502020204030204" pitchFamily="34" charset="0"/>
                <a:ea typeface="MS Mincho"/>
              </a:rPr>
              <a:t>(C)</a:t>
            </a:r>
            <a:r>
              <a:rPr lang="en-US" sz="1400" dirty="0">
                <a:latin typeface="Calibri" panose="020F0502020204030204" pitchFamily="34" charset="0"/>
                <a:ea typeface="MS Mincho"/>
              </a:rPr>
              <a:t>. Caregivers of enrolled patients will be screened for eligibility and approached for study participation before the related patient is randomized </a:t>
            </a:r>
            <a:r>
              <a:rPr lang="en-US" sz="1400" b="1" dirty="0">
                <a:latin typeface="Calibri" panose="020F0502020204030204" pitchFamily="34" charset="0"/>
                <a:ea typeface="MS Mincho"/>
              </a:rPr>
              <a:t>(D)</a:t>
            </a:r>
            <a:r>
              <a:rPr lang="en-US" sz="1400" dirty="0">
                <a:latin typeface="Calibri" panose="020F0502020204030204" pitchFamily="34" charset="0"/>
                <a:ea typeface="MS Mincho"/>
              </a:rPr>
              <a:t>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048328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21A2B3FAE9B5446BAA6036F387D82F7" ma:contentTypeVersion="4" ma:contentTypeDescription="Create a new document." ma:contentTypeScope="" ma:versionID="616b377f1153411035433437d9b804a4">
  <xsd:schema xmlns:xsd="http://www.w3.org/2001/XMLSchema" xmlns:xs="http://www.w3.org/2001/XMLSchema" xmlns:p="http://schemas.microsoft.com/office/2006/metadata/properties" xmlns:ns2="990a778d-e4da-4736-863c-f08c3764049b" targetNamespace="http://schemas.microsoft.com/office/2006/metadata/properties" ma:root="true" ma:fieldsID="913146f5a34e01df34f5143cbd0bfdc3" ns2:_="">
    <xsd:import namespace="990a778d-e4da-4736-863c-f08c3764049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90a778d-e4da-4736-863c-f08c3764049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E2BD286-FBE7-42DC-8F3E-0C49863FFE15}"/>
</file>

<file path=customXml/itemProps2.xml><?xml version="1.0" encoding="utf-8"?>
<ds:datastoreItem xmlns:ds="http://schemas.openxmlformats.org/officeDocument/2006/customXml" ds:itemID="{0056F3C1-669C-422C-A9E5-1E8E3EAC0FD1}"/>
</file>

<file path=customXml/itemProps3.xml><?xml version="1.0" encoding="utf-8"?>
<ds:datastoreItem xmlns:ds="http://schemas.openxmlformats.org/officeDocument/2006/customXml" ds:itemID="{19D35962-F2ED-40E7-BAFD-C129C90E7A69}"/>
</file>

<file path=docProps/app.xml><?xml version="1.0" encoding="utf-8"?>
<Properties xmlns="http://schemas.openxmlformats.org/officeDocument/2006/extended-properties" xmlns:vt="http://schemas.openxmlformats.org/officeDocument/2006/docPropsVTypes">
  <TotalTime>203</TotalTime>
  <Words>204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F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a Murea</dc:creator>
  <cp:lastModifiedBy>Mariana Murea</cp:lastModifiedBy>
  <cp:revision>38</cp:revision>
  <dcterms:created xsi:type="dcterms:W3CDTF">2022-03-29T23:54:46Z</dcterms:created>
  <dcterms:modified xsi:type="dcterms:W3CDTF">2024-01-06T23:21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21A2B3FAE9B5446BAA6036F387D82F7</vt:lpwstr>
  </property>
</Properties>
</file>